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61" r:id="rId5"/>
    <p:sldId id="260" r:id="rId6"/>
    <p:sldId id="259" r:id="rId7"/>
  </p:sldIdLst>
  <p:sldSz cx="6858000" cy="9906000" type="A4"/>
  <p:notesSz cx="6858000" cy="9144000"/>
  <p:defaultTextStyle>
    <a:defPPr>
      <a:defRPr lang="en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457"/>
    <p:restoredTop sz="94669"/>
  </p:normalViewPr>
  <p:slideViewPr>
    <p:cSldViewPr snapToGrid="0">
      <p:cViewPr>
        <p:scale>
          <a:sx n="155" d="100"/>
          <a:sy n="155" d="100"/>
        </p:scale>
        <p:origin x="528" y="-4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8C5B1C-7EEB-9FDC-FCA0-E7E9FFB7CF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DCBD23-3B1A-E56C-026B-62DFD1BCFB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GB"/>
              <a:t>Click to edit Master subtitle style</a:t>
            </a:r>
            <a:endParaRPr lang="en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72FA40-65C3-A4FC-B485-353D17C90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5BF96-718C-9148-838C-429A81ACACEF}" type="datetimeFigureOut">
              <a:rPr lang="en-NO" smtClean="0"/>
              <a:t>11/12/2025</a:t>
            </a:fld>
            <a:endParaRPr lang="en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D930E7-6FDA-33CF-74C4-52CC50DA5B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DE6AF9-0C0B-95D1-CF1B-7255605EA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F0ECE-B4EB-7E49-B590-B91B46204EA9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595392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BBEF47-653E-A928-FC45-877D4D5A18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931D32-D6F4-0501-3668-77A80F8C2A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E4027D-8D04-5A5B-60AB-92F4A88F5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5BF96-718C-9148-838C-429A81ACACEF}" type="datetimeFigureOut">
              <a:rPr lang="en-NO" smtClean="0"/>
              <a:t>11/12/2025</a:t>
            </a:fld>
            <a:endParaRPr lang="en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065184-E224-8659-F16E-80C01F7BF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ED3B71-B9C3-F5CC-402D-E44A65704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F0ECE-B4EB-7E49-B590-B91B46204EA9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329663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EDA213E-7A85-53B5-DC44-03DBF53339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D2ACCE-A4C7-EC59-57CA-FA7484D83E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8CC536-EED5-2C49-3968-21F3C3F31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5BF96-718C-9148-838C-429A81ACACEF}" type="datetimeFigureOut">
              <a:rPr lang="en-NO" smtClean="0"/>
              <a:t>11/12/2025</a:t>
            </a:fld>
            <a:endParaRPr lang="en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82D4A8-CD1A-9ABC-B0B4-8E382596E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FD2A44-854C-9D79-27ED-8F86730B8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F0ECE-B4EB-7E49-B590-B91B46204EA9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4800877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3EC85B-3809-8505-57E7-46F3CBC811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387167-4AAD-D23D-7C7F-258E313AF4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9974F1-EF56-3256-C9F2-46737CAE6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5BF96-718C-9148-838C-429A81ACACEF}" type="datetimeFigureOut">
              <a:rPr lang="en-NO" smtClean="0"/>
              <a:t>11/12/2025</a:t>
            </a:fld>
            <a:endParaRPr lang="en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F2813B-3B66-36A1-DA1B-4219AED4E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4300F9-060B-3395-E1DD-7DDA10573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F0ECE-B4EB-7E49-B590-B91B46204EA9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48021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8CCAEE-28D9-7286-0F6F-DF6E2E39E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04C266-F26E-0E4F-88D2-75AB89CA8E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82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82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82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99C1EA-0C2A-1810-B6DD-58CFCD32E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5BF96-718C-9148-838C-429A81ACACEF}" type="datetimeFigureOut">
              <a:rPr lang="en-NO" smtClean="0"/>
              <a:t>11/12/2025</a:t>
            </a:fld>
            <a:endParaRPr lang="en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FF91F4-CF47-8C58-C54C-64A1031BE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79CF9E-D598-8C59-E0CA-5FFB0D0A0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F0ECE-B4EB-7E49-B590-B91B46204EA9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2844528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0C0A8B-3834-33DC-1350-BB3B71641F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1CD6A1-4BE9-182F-BA56-FA3FF2C0C1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859B00-69E0-D1D1-B80F-FE96F3E75F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37A759-6B45-39F4-4F8E-F2239BB73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5BF96-718C-9148-838C-429A81ACACEF}" type="datetimeFigureOut">
              <a:rPr lang="en-NO" smtClean="0"/>
              <a:t>11/12/2025</a:t>
            </a:fld>
            <a:endParaRPr lang="en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11732A-0313-ED36-4713-7B33F8140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3A1A13-1082-9285-DE34-655363BEB3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F0ECE-B4EB-7E49-B590-B91B46204EA9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282289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EE37FA-6086-4C07-C4E4-E5561D2D86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15B12A-B804-C6F6-7542-28CD05DAF5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1BB736-AB74-36D2-6FDE-1E7A66BD23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1C0598-8AF0-926C-1569-B875EC2C4A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6487963-E0B3-72FA-127B-0B222BA3C35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2DFC78-A9BB-805A-F2EB-4DBC1C6395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5BF96-718C-9148-838C-429A81ACACEF}" type="datetimeFigureOut">
              <a:rPr lang="en-NO" smtClean="0"/>
              <a:t>11/12/2025</a:t>
            </a:fld>
            <a:endParaRPr lang="en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382FCBB-8785-DFE8-CB24-778D2BA23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CA0B6CF-3306-B526-161D-F2218D868C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F0ECE-B4EB-7E49-B590-B91B46204EA9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4115840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C772A-9E41-656A-3A56-218BE10958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6D1CC8C-C194-3492-70BF-6C09EDDA2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5BF96-718C-9148-838C-429A81ACACEF}" type="datetimeFigureOut">
              <a:rPr lang="en-NO" smtClean="0"/>
              <a:t>11/12/2025</a:t>
            </a:fld>
            <a:endParaRPr lang="en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E4DB24-24A2-C6E4-C90B-63133359B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FBE4CA-8A3A-A462-7EEA-9298935A2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F0ECE-B4EB-7E49-B590-B91B46204EA9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1004692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F3BE399-4979-3328-4DB5-FC0C138235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5BF96-718C-9148-838C-429A81ACACEF}" type="datetimeFigureOut">
              <a:rPr lang="en-NO" smtClean="0"/>
              <a:t>11/12/2025</a:t>
            </a:fld>
            <a:endParaRPr lang="en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01F60E6-E904-39C5-5F4F-1E81694F7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FC0CB02-6778-D39A-2EC5-40324E61D4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F0ECE-B4EB-7E49-B590-B91B46204EA9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8716862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B42F19-A892-D95E-DFBC-AD7F0808A0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51F934-8F33-F65B-A911-6AFD8FF20E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AD7A1E-2CCA-BF17-A254-04E621E91F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105D46-3D2B-FD56-7773-B972CFFF2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5BF96-718C-9148-838C-429A81ACACEF}" type="datetimeFigureOut">
              <a:rPr lang="en-NO" smtClean="0"/>
              <a:t>11/12/2025</a:t>
            </a:fld>
            <a:endParaRPr lang="en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38A519-E837-D0B6-EA35-4AA93BB43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F69CF0-32EB-85BF-8A03-FABEB3A04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F0ECE-B4EB-7E49-B590-B91B46204EA9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961625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F89CFF-8062-6767-7CB1-9A96B3A2C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BE39671-0163-44B2-CDE7-470617A6C4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0601EF-C55D-D112-5216-A83EDEEED3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EAABEC-3BB2-EC8B-E16E-F11EF9C5A8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5BF96-718C-9148-838C-429A81ACACEF}" type="datetimeFigureOut">
              <a:rPr lang="en-NO" smtClean="0"/>
              <a:t>11/12/2025</a:t>
            </a:fld>
            <a:endParaRPr lang="en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469F4F-58C6-F08C-AA71-DD2CEE503F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41B7DD-FE9F-708D-EEFD-379C8CD661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F0ECE-B4EB-7E49-B590-B91B46204EA9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1906965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2C2185C-E47C-9330-ADA6-B02CB7F97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0178AF-5CC6-6735-F2E9-2FEB518189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993E02-9EEC-2727-FF8E-312CCF816C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7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FA5BF96-718C-9148-838C-429A81ACACEF}" type="datetimeFigureOut">
              <a:rPr lang="en-NO" smtClean="0"/>
              <a:t>11/12/2025</a:t>
            </a:fld>
            <a:endParaRPr lang="en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D9DA89-14E8-9293-D53A-E1D071D326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E73921-6787-A9C4-110B-3BE6A048B9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2F0ECE-B4EB-7E49-B590-B91B46204EA9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903271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NO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3B7C6FC-5E4E-AD3C-7D79-F8566E773B68}"/>
              </a:ext>
            </a:extLst>
          </p:cNvPr>
          <p:cNvSpPr txBox="1"/>
          <p:nvPr/>
        </p:nvSpPr>
        <p:spPr>
          <a:xfrm>
            <a:off x="641130" y="55704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dirty="0">
                <a:latin typeface="Helvetica" pitchFamily="2" charset="0"/>
              </a:rPr>
              <a:t>Figure 4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5666193-EED3-063B-2777-AAAC7DDD3CBC}"/>
              </a:ext>
            </a:extLst>
          </p:cNvPr>
          <p:cNvSpPr txBox="1"/>
          <p:nvPr/>
        </p:nvSpPr>
        <p:spPr>
          <a:xfrm>
            <a:off x="641130" y="922695"/>
            <a:ext cx="2885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O" sz="1400" b="1" dirty="0">
                <a:latin typeface="Helvetica" pitchFamily="2" charset="0"/>
              </a:rPr>
              <a:t>G7: </a:t>
            </a:r>
            <a:r>
              <a:rPr lang="en-NO" sz="1400" dirty="0">
                <a:latin typeface="Helvetica" pitchFamily="2" charset="0"/>
              </a:rPr>
              <a:t>Total RNAPII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108F103D-18AF-F094-D59C-D0F7911E4513}"/>
              </a:ext>
            </a:extLst>
          </p:cNvPr>
          <p:cNvGrpSpPr/>
          <p:nvPr/>
        </p:nvGrpSpPr>
        <p:grpSpPr>
          <a:xfrm>
            <a:off x="1636322" y="922695"/>
            <a:ext cx="2540767" cy="3267927"/>
            <a:chOff x="742942" y="1583025"/>
            <a:chExt cx="2540767" cy="3267927"/>
          </a:xfrm>
        </p:grpSpPr>
        <p:pic>
          <p:nvPicPr>
            <p:cNvPr id="5" name="Bilde 5" descr="Et bilde som inneholder lys, gitar&#10;&#10;Automatisk generert beskrivelse">
              <a:extLst>
                <a:ext uri="{FF2B5EF4-FFF2-40B4-BE49-F238E27FC236}">
                  <a16:creationId xmlns:a16="http://schemas.microsoft.com/office/drawing/2014/main" id="{2B9CBA4D-9691-780A-4C63-5A9A692329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265" t="26035" r="22780" b="5985"/>
            <a:stretch>
              <a:fillRect/>
            </a:stretch>
          </p:blipFill>
          <p:spPr bwMode="auto">
            <a:xfrm>
              <a:off x="1528481" y="2044690"/>
              <a:ext cx="1755228" cy="2806262"/>
            </a:xfrm>
            <a:prstGeom prst="rect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  <a:extLst>
                <a:ext uri="{C807C97D-BFC1-408E-A445-0C87EB9F89A2}">
                  <ask:lineSketchStyleProps xmlns:ask="http://schemas.microsoft.com/office/drawing/2018/sketchyshapes" sd="0">
                    <a:custGeom>
                      <a:avLst/>
                      <a:gdLst/>
                      <a:ahLst/>
                      <a:cxnLst/>
                      <a:rect l="0" t="0" r="0" b="0"/>
                      <a:pathLst/>
                    </a:custGeom>
                    <ask:type/>
                  </ask:lineSketchStyleProps>
                </a:ext>
              </a:extLst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D35ED61-06D8-9DEE-6B25-C22C2C7C8075}"/>
                </a:ext>
              </a:extLst>
            </p:cNvPr>
            <p:cNvSpPr txBox="1"/>
            <p:nvPr/>
          </p:nvSpPr>
          <p:spPr>
            <a:xfrm>
              <a:off x="1443141" y="1583025"/>
              <a:ext cx="184056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0 nM THZ531</a:t>
              </a:r>
            </a:p>
            <a:p>
              <a:r>
                <a:rPr lang="en-NO" sz="1200" dirty="0">
                  <a:latin typeface="Helvetica" pitchFamily="2" charset="0"/>
                </a:rPr>
                <a:t>DMSO – 6h – 24h – 48h</a:t>
              </a:r>
              <a:endParaRPr lang="en-NO" sz="12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418BC44-7263-11B7-F511-DC429F2255B2}"/>
                </a:ext>
              </a:extLst>
            </p:cNvPr>
            <p:cNvSpPr txBox="1"/>
            <p:nvPr/>
          </p:nvSpPr>
          <p:spPr>
            <a:xfrm>
              <a:off x="742943" y="3011302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98BB124-DC33-BEFC-6923-FC270AE5B815}"/>
                </a:ext>
              </a:extLst>
            </p:cNvPr>
            <p:cNvSpPr txBox="1"/>
            <p:nvPr/>
          </p:nvSpPr>
          <p:spPr>
            <a:xfrm>
              <a:off x="742942" y="3319831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0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09D0258-96B0-77AF-BCE5-BF72AE97AC19}"/>
                </a:ext>
              </a:extLst>
            </p:cNvPr>
            <p:cNvSpPr txBox="1"/>
            <p:nvPr/>
          </p:nvSpPr>
          <p:spPr>
            <a:xfrm>
              <a:off x="828282" y="3548521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F453909-88F5-EEDB-8134-8FF2F6ECEAF8}"/>
                </a:ext>
              </a:extLst>
            </p:cNvPr>
            <p:cNvSpPr txBox="1"/>
            <p:nvPr/>
          </p:nvSpPr>
          <p:spPr>
            <a:xfrm>
              <a:off x="828282" y="3971046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25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333B0386-D00E-A2C7-60A4-6E142097EDCB}"/>
              </a:ext>
            </a:extLst>
          </p:cNvPr>
          <p:cNvSpPr txBox="1"/>
          <p:nvPr/>
        </p:nvSpPr>
        <p:spPr>
          <a:xfrm>
            <a:off x="795455" y="5311122"/>
            <a:ext cx="2885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O" sz="1400" b="1" dirty="0">
                <a:latin typeface="Helvetica" pitchFamily="2" charset="0"/>
              </a:rPr>
              <a:t>G7:</a:t>
            </a:r>
            <a:r>
              <a:rPr lang="en-NO" sz="1400" dirty="0">
                <a:latin typeface="Helvetica" pitchFamily="2" charset="0"/>
              </a:rPr>
              <a:t> pSer2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D97A1D9A-3278-A71D-1F73-8FCADBC26395}"/>
              </a:ext>
            </a:extLst>
          </p:cNvPr>
          <p:cNvGrpSpPr/>
          <p:nvPr/>
        </p:nvGrpSpPr>
        <p:grpSpPr>
          <a:xfrm>
            <a:off x="1826070" y="5552088"/>
            <a:ext cx="2468834" cy="2224298"/>
            <a:chOff x="742943" y="1835632"/>
            <a:chExt cx="2468834" cy="2224298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3777794-1C5C-4A5B-F514-2F10FFCD40D1}"/>
                </a:ext>
              </a:extLst>
            </p:cNvPr>
            <p:cNvSpPr txBox="1"/>
            <p:nvPr/>
          </p:nvSpPr>
          <p:spPr>
            <a:xfrm>
              <a:off x="1371209" y="1835632"/>
              <a:ext cx="184056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0 nM THZ531</a:t>
              </a:r>
            </a:p>
            <a:p>
              <a:r>
                <a:rPr lang="en-NO" sz="1200" dirty="0">
                  <a:latin typeface="Helvetica" pitchFamily="2" charset="0"/>
                </a:rPr>
                <a:t>DMSO – 6h – 24h – 48h</a:t>
              </a:r>
              <a:endParaRPr lang="en-NO" sz="120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4D55515-11C8-59E5-57DE-5A45567EA671}"/>
                </a:ext>
              </a:extLst>
            </p:cNvPr>
            <p:cNvSpPr txBox="1"/>
            <p:nvPr/>
          </p:nvSpPr>
          <p:spPr>
            <a:xfrm>
              <a:off x="742943" y="3011302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006ABB0-B8AD-0157-0212-131070BA4E46}"/>
                </a:ext>
              </a:extLst>
            </p:cNvPr>
            <p:cNvSpPr txBox="1"/>
            <p:nvPr/>
          </p:nvSpPr>
          <p:spPr>
            <a:xfrm>
              <a:off x="755309" y="3258617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0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3B336DF-6425-EEAF-3FCB-5695EE173FCE}"/>
                </a:ext>
              </a:extLst>
            </p:cNvPr>
            <p:cNvSpPr txBox="1"/>
            <p:nvPr/>
          </p:nvSpPr>
          <p:spPr>
            <a:xfrm>
              <a:off x="828281" y="3446732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11239F00-15FD-7321-6265-14E6431EE58D}"/>
                </a:ext>
              </a:extLst>
            </p:cNvPr>
            <p:cNvSpPr txBox="1"/>
            <p:nvPr/>
          </p:nvSpPr>
          <p:spPr>
            <a:xfrm>
              <a:off x="828280" y="3782931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25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</p:grpSp>
      <p:pic>
        <p:nvPicPr>
          <p:cNvPr id="27" name="Bilde 1" descr="A close up of a dna test&#10;&#10;AI-generated content may be incorrect.">
            <a:extLst>
              <a:ext uri="{FF2B5EF4-FFF2-40B4-BE49-F238E27FC236}">
                <a16:creationId xmlns:a16="http://schemas.microsoft.com/office/drawing/2014/main" id="{B18326A7-8543-68D7-C64C-05AC18C8723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1144" t="20167" r="18857" b="8232"/>
          <a:stretch>
            <a:fillRect/>
          </a:stretch>
        </p:blipFill>
        <p:spPr bwMode="auto">
          <a:xfrm>
            <a:off x="2598411" y="6051050"/>
            <a:ext cx="1500137" cy="252248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8" name="Rectangle 27">
            <a:extLst>
              <a:ext uri="{FF2B5EF4-FFF2-40B4-BE49-F238E27FC236}">
                <a16:creationId xmlns:a16="http://schemas.microsoft.com/office/drawing/2014/main" id="{C4BD8A47-15D3-B113-0E72-A1885F32E537}"/>
              </a:ext>
            </a:extLst>
          </p:cNvPr>
          <p:cNvSpPr/>
          <p:nvPr/>
        </p:nvSpPr>
        <p:spPr>
          <a:xfrm>
            <a:off x="2486125" y="1755228"/>
            <a:ext cx="1654949" cy="430924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3BF4715-70E1-06AE-E4A5-F532709F52C1}"/>
              </a:ext>
            </a:extLst>
          </p:cNvPr>
          <p:cNvSpPr/>
          <p:nvPr/>
        </p:nvSpPr>
        <p:spPr>
          <a:xfrm>
            <a:off x="2517170" y="6122679"/>
            <a:ext cx="1654949" cy="430924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8726326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EFC9BF1-6ADB-0919-6D65-9E1322D4C65D}"/>
              </a:ext>
            </a:extLst>
          </p:cNvPr>
          <p:cNvSpPr txBox="1"/>
          <p:nvPr/>
        </p:nvSpPr>
        <p:spPr>
          <a:xfrm>
            <a:off x="676551" y="941827"/>
            <a:ext cx="2885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O" sz="1400" b="1" dirty="0">
                <a:latin typeface="Helvetica" pitchFamily="2" charset="0"/>
              </a:rPr>
              <a:t>G7:</a:t>
            </a:r>
            <a:r>
              <a:rPr lang="en-NO" sz="1400" dirty="0">
                <a:latin typeface="Helvetica" pitchFamily="2" charset="0"/>
              </a:rPr>
              <a:t> Thr4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95EC6743-4330-EDF9-927A-46BC23949209}"/>
              </a:ext>
            </a:extLst>
          </p:cNvPr>
          <p:cNvGrpSpPr/>
          <p:nvPr/>
        </p:nvGrpSpPr>
        <p:grpSpPr>
          <a:xfrm>
            <a:off x="1685919" y="941827"/>
            <a:ext cx="2526591" cy="2857212"/>
            <a:chOff x="757118" y="1583025"/>
            <a:chExt cx="2526591" cy="2857212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25F58DF-614E-B9B0-3B2A-5AF093BFE09A}"/>
                </a:ext>
              </a:extLst>
            </p:cNvPr>
            <p:cNvSpPr txBox="1"/>
            <p:nvPr/>
          </p:nvSpPr>
          <p:spPr>
            <a:xfrm>
              <a:off x="1443141" y="1583025"/>
              <a:ext cx="184056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0 nM THZ531</a:t>
              </a:r>
            </a:p>
            <a:p>
              <a:r>
                <a:rPr lang="en-NO" sz="1200" dirty="0">
                  <a:latin typeface="Helvetica" pitchFamily="2" charset="0"/>
                </a:rPr>
                <a:t>DMSO – 6h – 24h – 48h</a:t>
              </a:r>
              <a:endParaRPr lang="en-NO" sz="12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F212401-B9E7-1383-41C4-89104F4287CE}"/>
                </a:ext>
              </a:extLst>
            </p:cNvPr>
            <p:cNvSpPr txBox="1"/>
            <p:nvPr/>
          </p:nvSpPr>
          <p:spPr>
            <a:xfrm>
              <a:off x="761544" y="2984347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B0F2C2D-28C3-26CF-5362-B3446314E1AA}"/>
                </a:ext>
              </a:extLst>
            </p:cNvPr>
            <p:cNvSpPr txBox="1"/>
            <p:nvPr/>
          </p:nvSpPr>
          <p:spPr>
            <a:xfrm>
              <a:off x="757118" y="3355271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0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0EB4720-079A-0D84-09E0-F4DE765566DF}"/>
                </a:ext>
              </a:extLst>
            </p:cNvPr>
            <p:cNvSpPr txBox="1"/>
            <p:nvPr/>
          </p:nvSpPr>
          <p:spPr>
            <a:xfrm>
              <a:off x="842458" y="3782425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35EA3C6-1632-C568-470C-44942746326D}"/>
                </a:ext>
              </a:extLst>
            </p:cNvPr>
            <p:cNvSpPr txBox="1"/>
            <p:nvPr/>
          </p:nvSpPr>
          <p:spPr>
            <a:xfrm>
              <a:off x="849546" y="4163238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25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895BAF2C-8FC5-87DF-EEE0-FDCFBE664662}"/>
              </a:ext>
            </a:extLst>
          </p:cNvPr>
          <p:cNvSpPr txBox="1"/>
          <p:nvPr/>
        </p:nvSpPr>
        <p:spPr>
          <a:xfrm>
            <a:off x="676551" y="5292749"/>
            <a:ext cx="2885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O" sz="1400" b="1" dirty="0">
                <a:latin typeface="Helvetica" pitchFamily="2" charset="0"/>
              </a:rPr>
              <a:t>G7:</a:t>
            </a:r>
            <a:r>
              <a:rPr lang="en-NO" sz="1400" dirty="0">
                <a:latin typeface="Helvetica" pitchFamily="2" charset="0"/>
              </a:rPr>
              <a:t> Ser5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7BA9DB9-A508-C421-843A-CA86155CD0BC}"/>
              </a:ext>
            </a:extLst>
          </p:cNvPr>
          <p:cNvGrpSpPr/>
          <p:nvPr/>
        </p:nvGrpSpPr>
        <p:grpSpPr>
          <a:xfrm>
            <a:off x="1671743" y="5292749"/>
            <a:ext cx="2540767" cy="2509084"/>
            <a:chOff x="742942" y="1583025"/>
            <a:chExt cx="2540767" cy="2509084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B92B1F3-F0F2-EE4A-2AF0-A863EFB4B054}"/>
                </a:ext>
              </a:extLst>
            </p:cNvPr>
            <p:cNvSpPr txBox="1"/>
            <p:nvPr/>
          </p:nvSpPr>
          <p:spPr>
            <a:xfrm>
              <a:off x="1443141" y="1583025"/>
              <a:ext cx="184056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0 nM THZ531</a:t>
              </a:r>
            </a:p>
            <a:p>
              <a:r>
                <a:rPr lang="en-NO" sz="1200" dirty="0">
                  <a:latin typeface="Helvetica" pitchFamily="2" charset="0"/>
                </a:rPr>
                <a:t>DMSO – 6h – 24h – 48h</a:t>
              </a:r>
              <a:endParaRPr lang="en-NO" sz="12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904EC5B-EC3D-1829-1EB7-9D8C7B026A25}"/>
                </a:ext>
              </a:extLst>
            </p:cNvPr>
            <p:cNvSpPr txBox="1"/>
            <p:nvPr/>
          </p:nvSpPr>
          <p:spPr>
            <a:xfrm>
              <a:off x="742943" y="3011302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467EE8C-24D5-E61F-1F8E-B7A29E100A2C}"/>
                </a:ext>
              </a:extLst>
            </p:cNvPr>
            <p:cNvSpPr txBox="1"/>
            <p:nvPr/>
          </p:nvSpPr>
          <p:spPr>
            <a:xfrm>
              <a:off x="742942" y="3248951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0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92268C4-227B-13E6-197B-F81144ED3D8D}"/>
                </a:ext>
              </a:extLst>
            </p:cNvPr>
            <p:cNvSpPr txBox="1"/>
            <p:nvPr/>
          </p:nvSpPr>
          <p:spPr>
            <a:xfrm>
              <a:off x="828282" y="3449289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A5D269D-3EC9-C341-6ADA-44D1A4937973}"/>
                </a:ext>
              </a:extLst>
            </p:cNvPr>
            <p:cNvSpPr txBox="1"/>
            <p:nvPr/>
          </p:nvSpPr>
          <p:spPr>
            <a:xfrm>
              <a:off x="828282" y="3815110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25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</p:grpSp>
      <p:pic>
        <p:nvPicPr>
          <p:cNvPr id="20" name="Bilde 4" descr="Et bilde som inneholder musikk, hvit, gitar, lys&#10;&#10;Automatisk generert beskrivelse">
            <a:extLst>
              <a:ext uri="{FF2B5EF4-FFF2-40B4-BE49-F238E27FC236}">
                <a16:creationId xmlns:a16="http://schemas.microsoft.com/office/drawing/2014/main" id="{44669CE5-AAA8-352D-0433-7AF6A8F82EB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375" t="24797" r="21141" b="3079"/>
          <a:stretch>
            <a:fillRect/>
          </a:stretch>
        </p:blipFill>
        <p:spPr bwMode="auto">
          <a:xfrm>
            <a:off x="2480172" y="1797462"/>
            <a:ext cx="1542398" cy="2571099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0E6AC83D-17CD-4C97-A67F-AEE309AA9FFF}"/>
              </a:ext>
            </a:extLst>
          </p:cNvPr>
          <p:cNvSpPr/>
          <p:nvPr/>
        </p:nvSpPr>
        <p:spPr>
          <a:xfrm>
            <a:off x="2608980" y="2144551"/>
            <a:ext cx="1225829" cy="373711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  <p:pic>
        <p:nvPicPr>
          <p:cNvPr id="21" name="Bilde 3" descr="Et bilde som inneholder tekst&#10;&#10;Automatisk generert beskrivelse">
            <a:extLst>
              <a:ext uri="{FF2B5EF4-FFF2-40B4-BE49-F238E27FC236}">
                <a16:creationId xmlns:a16="http://schemas.microsoft.com/office/drawing/2014/main" id="{95350F41-2856-D9B5-609D-670B430193A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5516" t="21916" r="44015" b="2780"/>
          <a:stretch>
            <a:fillRect/>
          </a:stretch>
        </p:blipFill>
        <p:spPr bwMode="auto">
          <a:xfrm>
            <a:off x="2468644" y="5915279"/>
            <a:ext cx="1542399" cy="2685932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id="{B034E3E2-E958-3679-5388-8A69FBFCE452}"/>
              </a:ext>
            </a:extLst>
          </p:cNvPr>
          <p:cNvSpPr/>
          <p:nvPr/>
        </p:nvSpPr>
        <p:spPr>
          <a:xfrm>
            <a:off x="2676743" y="6261802"/>
            <a:ext cx="1156698" cy="276999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1845286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15C0173-4AB2-32D4-1192-24D4DDC286E5}"/>
              </a:ext>
            </a:extLst>
          </p:cNvPr>
          <p:cNvSpPr txBox="1"/>
          <p:nvPr/>
        </p:nvSpPr>
        <p:spPr>
          <a:xfrm>
            <a:off x="696002" y="1532080"/>
            <a:ext cx="2885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O" sz="1400" b="1" dirty="0">
                <a:latin typeface="Helvetica" pitchFamily="2" charset="0"/>
              </a:rPr>
              <a:t>G7:</a:t>
            </a:r>
            <a:r>
              <a:rPr lang="en-NO" sz="1400" dirty="0">
                <a:latin typeface="Helvetica" pitchFamily="2" charset="0"/>
              </a:rPr>
              <a:t> pSer7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5A8F2186-4834-2C0F-4C71-36B62864EDDC}"/>
              </a:ext>
            </a:extLst>
          </p:cNvPr>
          <p:cNvGrpSpPr/>
          <p:nvPr/>
        </p:nvGrpSpPr>
        <p:grpSpPr>
          <a:xfrm>
            <a:off x="1691195" y="1532080"/>
            <a:ext cx="2540766" cy="1705276"/>
            <a:chOff x="742943" y="1583025"/>
            <a:chExt cx="2540766" cy="1705276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6B7A3BA-3D6C-30BC-83A8-900E0818A007}"/>
                </a:ext>
              </a:extLst>
            </p:cNvPr>
            <p:cNvSpPr txBox="1"/>
            <p:nvPr/>
          </p:nvSpPr>
          <p:spPr>
            <a:xfrm>
              <a:off x="1443141" y="1583025"/>
              <a:ext cx="184056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0 nM THZ531</a:t>
              </a:r>
            </a:p>
            <a:p>
              <a:r>
                <a:rPr lang="en-NO" sz="1200" dirty="0">
                  <a:latin typeface="Helvetica" pitchFamily="2" charset="0"/>
                </a:rPr>
                <a:t>DMSO – 6h – 24h – 48h</a:t>
              </a:r>
              <a:endParaRPr lang="en-NO" sz="1200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01419CB-07A9-1987-6AD0-74E20BD5A4DF}"/>
                </a:ext>
              </a:extLst>
            </p:cNvPr>
            <p:cNvSpPr txBox="1"/>
            <p:nvPr/>
          </p:nvSpPr>
          <p:spPr>
            <a:xfrm>
              <a:off x="742943" y="3011302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90DEE125-EEA6-15B5-42C8-1E2CBFF285A2}"/>
              </a:ext>
            </a:extLst>
          </p:cNvPr>
          <p:cNvSpPr txBox="1"/>
          <p:nvPr/>
        </p:nvSpPr>
        <p:spPr>
          <a:xfrm>
            <a:off x="676551" y="5292749"/>
            <a:ext cx="2885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O" sz="1400" b="1" dirty="0">
                <a:latin typeface="Helvetica" pitchFamily="2" charset="0"/>
              </a:rPr>
              <a:t>G7:</a:t>
            </a:r>
            <a:r>
              <a:rPr lang="en-NO" sz="1400" dirty="0">
                <a:latin typeface="Helvetica" pitchFamily="2" charset="0"/>
              </a:rPr>
              <a:t> Vinculin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D4795EE1-EF48-1BE0-EAA1-83C27D68021D}"/>
              </a:ext>
            </a:extLst>
          </p:cNvPr>
          <p:cNvGrpSpPr/>
          <p:nvPr/>
        </p:nvGrpSpPr>
        <p:grpSpPr>
          <a:xfrm>
            <a:off x="1671743" y="5292749"/>
            <a:ext cx="2540767" cy="3144628"/>
            <a:chOff x="742942" y="1583025"/>
            <a:chExt cx="2540767" cy="3144628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947F3CF-D86F-8E56-D6DE-E689F94474C3}"/>
                </a:ext>
              </a:extLst>
            </p:cNvPr>
            <p:cNvSpPr txBox="1"/>
            <p:nvPr/>
          </p:nvSpPr>
          <p:spPr>
            <a:xfrm>
              <a:off x="1443141" y="1583025"/>
              <a:ext cx="184056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0 nM THZ531</a:t>
              </a:r>
            </a:p>
            <a:p>
              <a:r>
                <a:rPr lang="en-NO" sz="1200" dirty="0">
                  <a:latin typeface="Helvetica" pitchFamily="2" charset="0"/>
                </a:rPr>
                <a:t>DMSO – 6h – 24h – 48h</a:t>
              </a:r>
              <a:endParaRPr lang="en-NO" sz="12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8FD9330-B16A-F1E8-A778-145353CE9CBF}"/>
                </a:ext>
              </a:extLst>
            </p:cNvPr>
            <p:cNvSpPr txBox="1"/>
            <p:nvPr/>
          </p:nvSpPr>
          <p:spPr>
            <a:xfrm>
              <a:off x="742942" y="3264116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DC2BE18-4C26-0F31-164B-F1CDBBD1A2B8}"/>
                </a:ext>
              </a:extLst>
            </p:cNvPr>
            <p:cNvSpPr txBox="1"/>
            <p:nvPr/>
          </p:nvSpPr>
          <p:spPr>
            <a:xfrm>
              <a:off x="742942" y="3832326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0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5034721-2F1F-8F38-809A-CAFEF2BF8736}"/>
                </a:ext>
              </a:extLst>
            </p:cNvPr>
            <p:cNvSpPr txBox="1"/>
            <p:nvPr/>
          </p:nvSpPr>
          <p:spPr>
            <a:xfrm>
              <a:off x="828282" y="4450654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</p:grpSp>
      <p:pic>
        <p:nvPicPr>
          <p:cNvPr id="18" name="Bilde 7" descr="A blurry image of a building&#10;&#10;AI-generated content may be incorrect.">
            <a:extLst>
              <a:ext uri="{FF2B5EF4-FFF2-40B4-BE49-F238E27FC236}">
                <a16:creationId xmlns:a16="http://schemas.microsoft.com/office/drawing/2014/main" id="{A4EF1ECC-A303-C353-C093-F4B3251121F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2593" t="38076" r="15035" b="8676"/>
          <a:stretch>
            <a:fillRect/>
          </a:stretch>
        </p:blipFill>
        <p:spPr bwMode="auto">
          <a:xfrm>
            <a:off x="2484202" y="2155167"/>
            <a:ext cx="1654949" cy="1918156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0EC7FEC2-5A3E-E8FA-6B69-EAF5A38C8343}"/>
              </a:ext>
            </a:extLst>
          </p:cNvPr>
          <p:cNvSpPr/>
          <p:nvPr/>
        </p:nvSpPr>
        <p:spPr>
          <a:xfrm>
            <a:off x="2726964" y="2813934"/>
            <a:ext cx="1027814" cy="331175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  <p:pic>
        <p:nvPicPr>
          <p:cNvPr id="19" name="Bilde 2" descr="A blurry image of a grid&#10;&#10;AI-generated content may be incorrect.">
            <a:extLst>
              <a:ext uri="{FF2B5EF4-FFF2-40B4-BE49-F238E27FC236}">
                <a16:creationId xmlns:a16="http://schemas.microsoft.com/office/drawing/2014/main" id="{39EB2925-7AA4-FC25-E9D0-F39FB78FD02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167" t="19068" r="43773" b="17000"/>
          <a:stretch>
            <a:fillRect/>
          </a:stretch>
        </p:blipFill>
        <p:spPr bwMode="auto">
          <a:xfrm>
            <a:off x="2451237" y="5820187"/>
            <a:ext cx="2333416" cy="327814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3C85AD93-0592-05A7-2E0A-74BC37A228B0}"/>
              </a:ext>
            </a:extLst>
          </p:cNvPr>
          <p:cNvSpPr/>
          <p:nvPr/>
        </p:nvSpPr>
        <p:spPr>
          <a:xfrm>
            <a:off x="2790470" y="7219068"/>
            <a:ext cx="1654949" cy="430924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7151737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4DB6A7F-4567-DF5B-AE8E-270D3965BAA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ECE783D6-5C19-DDB8-11E8-E32FBA7F7FC7}"/>
              </a:ext>
            </a:extLst>
          </p:cNvPr>
          <p:cNvSpPr txBox="1"/>
          <p:nvPr/>
        </p:nvSpPr>
        <p:spPr>
          <a:xfrm>
            <a:off x="3609324" y="2269357"/>
            <a:ext cx="2885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O" sz="1400" b="1" dirty="0">
                <a:latin typeface="Helvetica" pitchFamily="2" charset="0"/>
              </a:rPr>
              <a:t>Hela:</a:t>
            </a:r>
            <a:r>
              <a:rPr lang="en-NO" sz="1400" dirty="0">
                <a:latin typeface="Helvetica" pitchFamily="2" charset="0"/>
              </a:rPr>
              <a:t> pSer2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9B625313-7EFD-F4DE-F40C-B2CA5466A69E}"/>
              </a:ext>
            </a:extLst>
          </p:cNvPr>
          <p:cNvGrpSpPr/>
          <p:nvPr/>
        </p:nvGrpSpPr>
        <p:grpSpPr>
          <a:xfrm>
            <a:off x="1373305" y="2272540"/>
            <a:ext cx="4111389" cy="3347940"/>
            <a:chOff x="2084805" y="5008245"/>
            <a:chExt cx="4111389" cy="3347940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381A21B-7F72-ABFA-6274-9534F662F426}"/>
                </a:ext>
              </a:extLst>
            </p:cNvPr>
            <p:cNvSpPr txBox="1"/>
            <p:nvPr/>
          </p:nvSpPr>
          <p:spPr>
            <a:xfrm>
              <a:off x="2390881" y="5008245"/>
              <a:ext cx="28850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O" sz="1400" b="1" dirty="0">
                  <a:latin typeface="Helvetica" pitchFamily="2" charset="0"/>
                </a:rPr>
                <a:t>Hela: </a:t>
              </a:r>
              <a:r>
                <a:rPr lang="en-NO" sz="1400" dirty="0">
                  <a:latin typeface="Helvetica" pitchFamily="2" charset="0"/>
                </a:rPr>
                <a:t>Total RNAPII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BBFB4443-F84C-96E3-9A44-19B9AF12E074}"/>
                </a:ext>
              </a:extLst>
            </p:cNvPr>
            <p:cNvGrpSpPr/>
            <p:nvPr/>
          </p:nvGrpSpPr>
          <p:grpSpPr>
            <a:xfrm>
              <a:off x="2084805" y="5450799"/>
              <a:ext cx="2203710" cy="2425739"/>
              <a:chOff x="928415" y="1587187"/>
              <a:chExt cx="2203710" cy="2425739"/>
            </a:xfrm>
          </p:grpSpPr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92BD7622-110D-7A5C-CD7C-FCE9C2A9EA2C}"/>
                  </a:ext>
                </a:extLst>
              </p:cNvPr>
              <p:cNvSpPr txBox="1"/>
              <p:nvPr/>
            </p:nvSpPr>
            <p:spPr>
              <a:xfrm>
                <a:off x="1291557" y="1587187"/>
                <a:ext cx="184056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O" sz="1200" dirty="0">
                    <a:latin typeface="Helvetica" pitchFamily="2" charset="0"/>
                  </a:rPr>
                  <a:t>500 nM THZ531</a:t>
                </a:r>
              </a:p>
              <a:p>
                <a:r>
                  <a:rPr lang="en-NO" sz="1200" dirty="0">
                    <a:latin typeface="Helvetica" pitchFamily="2" charset="0"/>
                  </a:rPr>
                  <a:t>DMSO – 6h – 24h – 48h</a:t>
                </a:r>
                <a:endParaRPr lang="en-NO" sz="1200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8F995271-D669-1278-C620-416616676FC1}"/>
                  </a:ext>
                </a:extLst>
              </p:cNvPr>
              <p:cNvSpPr txBox="1"/>
              <p:nvPr/>
            </p:nvSpPr>
            <p:spPr>
              <a:xfrm>
                <a:off x="943718" y="2861716"/>
                <a:ext cx="115669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NO" sz="1200" dirty="0">
                    <a:latin typeface="Helvetica" pitchFamily="2" charset="0"/>
                  </a:rPr>
                  <a:t>150 kDa </a:t>
                </a:r>
                <a:r>
                  <a:rPr lang="en-NO" sz="1200" b="1" dirty="0">
                    <a:latin typeface="Helvetica" pitchFamily="2" charset="0"/>
                  </a:rPr>
                  <a:t>–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F08A2EC2-988D-6F19-CB85-83B920BF8636}"/>
                  </a:ext>
                </a:extLst>
              </p:cNvPr>
              <p:cNvSpPr txBox="1"/>
              <p:nvPr/>
            </p:nvSpPr>
            <p:spPr>
              <a:xfrm>
                <a:off x="928415" y="3139925"/>
                <a:ext cx="115669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NO" sz="1200" dirty="0">
                    <a:latin typeface="Helvetica" pitchFamily="2" charset="0"/>
                  </a:rPr>
                  <a:t>100 kDa </a:t>
                </a:r>
                <a:r>
                  <a:rPr lang="en-NO" sz="1200" b="1" dirty="0">
                    <a:latin typeface="Helvetica" pitchFamily="2" charset="0"/>
                  </a:rPr>
                  <a:t>–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97B7A8F9-0DA6-96E4-0547-5E59ED3B1470}"/>
                  </a:ext>
                </a:extLst>
              </p:cNvPr>
              <p:cNvSpPr txBox="1"/>
              <p:nvPr/>
            </p:nvSpPr>
            <p:spPr>
              <a:xfrm>
                <a:off x="1045704" y="3397907"/>
                <a:ext cx="115669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NO" sz="1200" dirty="0">
                    <a:latin typeface="Helvetica" pitchFamily="2" charset="0"/>
                  </a:rPr>
                  <a:t>50 kDa </a:t>
                </a:r>
                <a:r>
                  <a:rPr lang="en-NO" sz="1200" b="1" dirty="0">
                    <a:latin typeface="Helvetica" pitchFamily="2" charset="0"/>
                  </a:rPr>
                  <a:t>–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2A0A5726-990C-643D-425E-0685BB2F38C8}"/>
                  </a:ext>
                </a:extLst>
              </p:cNvPr>
              <p:cNvSpPr txBox="1"/>
              <p:nvPr/>
            </p:nvSpPr>
            <p:spPr>
              <a:xfrm>
                <a:off x="1045654" y="3735927"/>
                <a:ext cx="115669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NO" sz="1200" dirty="0">
                    <a:latin typeface="Helvetica" pitchFamily="2" charset="0"/>
                  </a:rPr>
                  <a:t>25 kDa </a:t>
                </a:r>
                <a:r>
                  <a:rPr lang="en-NO" sz="1200" b="1" dirty="0">
                    <a:latin typeface="Helvetica" pitchFamily="2" charset="0"/>
                  </a:rPr>
                  <a:t>–</a:t>
                </a:r>
              </a:p>
            </p:txBody>
          </p:sp>
        </p:grpSp>
        <p:pic>
          <p:nvPicPr>
            <p:cNvPr id="28" name="Bilde 8" descr="Et bilde som inneholder gitar&#10;&#10;Automatisk generert beskrivelse">
              <a:extLst>
                <a:ext uri="{FF2B5EF4-FFF2-40B4-BE49-F238E27FC236}">
                  <a16:creationId xmlns:a16="http://schemas.microsoft.com/office/drawing/2014/main" id="{36CE0247-FD2D-9DEB-39B8-1532F0397C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3800" t="19876" r="24451" b="13395"/>
            <a:stretch>
              <a:fillRect/>
            </a:stretch>
          </p:blipFill>
          <p:spPr bwMode="auto">
            <a:xfrm>
              <a:off x="2878359" y="5908302"/>
              <a:ext cx="2694632" cy="2447883"/>
            </a:xfrm>
            <a:prstGeom prst="rect">
              <a:avLst/>
            </a:prstGeom>
            <a:ln>
              <a:solidFill>
                <a:schemeClr val="tx1"/>
              </a:solidFill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3A7D8EB-1CB8-CED2-F974-9599222BCFCC}"/>
                </a:ext>
              </a:extLst>
            </p:cNvPr>
            <p:cNvSpPr txBox="1"/>
            <p:nvPr/>
          </p:nvSpPr>
          <p:spPr>
            <a:xfrm>
              <a:off x="4355626" y="5450798"/>
              <a:ext cx="184056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0 nM THZ531</a:t>
              </a:r>
            </a:p>
            <a:p>
              <a:r>
                <a:rPr lang="en-NO" sz="1200" dirty="0">
                  <a:latin typeface="Helvetica" pitchFamily="2" charset="0"/>
                </a:rPr>
                <a:t>DMSO – 6h – 24h – 48h</a:t>
              </a:r>
              <a:endParaRPr lang="en-NO" sz="1200" dirty="0"/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5426C2D7-8E49-51CE-4778-58FF34148846}"/>
                </a:ext>
              </a:extLst>
            </p:cNvPr>
            <p:cNvSpPr/>
            <p:nvPr/>
          </p:nvSpPr>
          <p:spPr>
            <a:xfrm>
              <a:off x="3061895" y="6172684"/>
              <a:ext cx="1258929" cy="430924"/>
            </a:xfrm>
            <a:prstGeom prst="rect">
              <a:avLst/>
            </a:prstGeom>
            <a:noFill/>
            <a:ln>
              <a:solidFill>
                <a:schemeClr val="bg2">
                  <a:lumMod val="50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O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D207FCD4-1E85-7312-8070-FC3FF7010D0C}"/>
                </a:ext>
              </a:extLst>
            </p:cNvPr>
            <p:cNvSpPr/>
            <p:nvPr/>
          </p:nvSpPr>
          <p:spPr>
            <a:xfrm>
              <a:off x="4372945" y="6073819"/>
              <a:ext cx="1143435" cy="303480"/>
            </a:xfrm>
            <a:prstGeom prst="rect">
              <a:avLst/>
            </a:prstGeom>
            <a:noFill/>
            <a:ln>
              <a:solidFill>
                <a:schemeClr val="bg2">
                  <a:lumMod val="50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O"/>
            </a:p>
          </p:txBody>
        </p:sp>
      </p:grpSp>
    </p:spTree>
    <p:extLst>
      <p:ext uri="{BB962C8B-B14F-4D97-AF65-F5344CB8AC3E}">
        <p14:creationId xmlns:p14="http://schemas.microsoft.com/office/powerpoint/2010/main" val="7401994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BF830CF-644D-245F-5F1C-F862565A49F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4162275-1161-3165-9B82-150694E6129B}"/>
              </a:ext>
            </a:extLst>
          </p:cNvPr>
          <p:cNvSpPr txBox="1"/>
          <p:nvPr/>
        </p:nvSpPr>
        <p:spPr>
          <a:xfrm>
            <a:off x="1235593" y="971739"/>
            <a:ext cx="2885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O" sz="1400" b="1" dirty="0">
                <a:latin typeface="Helvetica" pitchFamily="2" charset="0"/>
              </a:rPr>
              <a:t>Hela:</a:t>
            </a:r>
            <a:r>
              <a:rPr lang="en-NO" sz="1400" dirty="0">
                <a:latin typeface="Helvetica" pitchFamily="2" charset="0"/>
              </a:rPr>
              <a:t> Thr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B165233-51B1-EE24-E550-F39AAEBECB53}"/>
              </a:ext>
            </a:extLst>
          </p:cNvPr>
          <p:cNvSpPr txBox="1"/>
          <p:nvPr/>
        </p:nvSpPr>
        <p:spPr>
          <a:xfrm>
            <a:off x="1184441" y="5378287"/>
            <a:ext cx="2885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O" sz="1400" b="1" dirty="0">
                <a:latin typeface="Helvetica" pitchFamily="2" charset="0"/>
              </a:rPr>
              <a:t>Hela:</a:t>
            </a:r>
            <a:r>
              <a:rPr lang="en-NO" sz="1400" dirty="0">
                <a:latin typeface="Helvetica" pitchFamily="2" charset="0"/>
              </a:rPr>
              <a:t> Ser5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2B2DDE73-7FB5-C87E-93C4-E2E3C3BCA089}"/>
              </a:ext>
            </a:extLst>
          </p:cNvPr>
          <p:cNvGrpSpPr/>
          <p:nvPr/>
        </p:nvGrpSpPr>
        <p:grpSpPr>
          <a:xfrm>
            <a:off x="2179633" y="5419918"/>
            <a:ext cx="2540767" cy="2433168"/>
            <a:chOff x="742942" y="1482292"/>
            <a:chExt cx="2540767" cy="2433168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116C873-7347-02A3-5960-3735992A586E}"/>
                </a:ext>
              </a:extLst>
            </p:cNvPr>
            <p:cNvSpPr txBox="1"/>
            <p:nvPr/>
          </p:nvSpPr>
          <p:spPr>
            <a:xfrm>
              <a:off x="1443141" y="1482292"/>
              <a:ext cx="184056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0 nM THZ531</a:t>
              </a:r>
            </a:p>
            <a:p>
              <a:r>
                <a:rPr lang="en-NO" sz="1200" dirty="0">
                  <a:latin typeface="Helvetica" pitchFamily="2" charset="0"/>
                </a:rPr>
                <a:t>DMSO – 6h – 24h – 48h</a:t>
              </a:r>
              <a:endParaRPr lang="en-NO" sz="12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F9C69D3-E091-A12B-CD2F-F92E0268D398}"/>
                </a:ext>
              </a:extLst>
            </p:cNvPr>
            <p:cNvSpPr txBox="1"/>
            <p:nvPr/>
          </p:nvSpPr>
          <p:spPr>
            <a:xfrm>
              <a:off x="742943" y="3011302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015EBCC-49C7-2DE0-10B1-DE391A933941}"/>
                </a:ext>
              </a:extLst>
            </p:cNvPr>
            <p:cNvSpPr txBox="1"/>
            <p:nvPr/>
          </p:nvSpPr>
          <p:spPr>
            <a:xfrm>
              <a:off x="742942" y="3319831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0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89860C9-9AF1-9B8E-5F31-3801676195B7}"/>
                </a:ext>
              </a:extLst>
            </p:cNvPr>
            <p:cNvSpPr txBox="1"/>
            <p:nvPr/>
          </p:nvSpPr>
          <p:spPr>
            <a:xfrm>
              <a:off x="828282" y="3638461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</p:grpSp>
      <p:pic>
        <p:nvPicPr>
          <p:cNvPr id="18" name="Bilde 11" descr="A close-up of a test&#10;&#10;AI-generated content may be incorrect.">
            <a:extLst>
              <a:ext uri="{FF2B5EF4-FFF2-40B4-BE49-F238E27FC236}">
                <a16:creationId xmlns:a16="http://schemas.microsoft.com/office/drawing/2014/main" id="{0C302C12-3EA9-0B82-7B73-B941D6C0739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5396" t="23096" r="44353" b="5464"/>
          <a:stretch>
            <a:fillRect/>
          </a:stretch>
        </p:blipFill>
        <p:spPr bwMode="auto">
          <a:xfrm>
            <a:off x="2983693" y="5899230"/>
            <a:ext cx="1632846" cy="2716453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grpSp>
        <p:nvGrpSpPr>
          <p:cNvPr id="19" name="Group 18">
            <a:extLst>
              <a:ext uri="{FF2B5EF4-FFF2-40B4-BE49-F238E27FC236}">
                <a16:creationId xmlns:a16="http://schemas.microsoft.com/office/drawing/2014/main" id="{72B4B03D-E566-65BA-4714-955D177863C5}"/>
              </a:ext>
            </a:extLst>
          </p:cNvPr>
          <p:cNvGrpSpPr/>
          <p:nvPr/>
        </p:nvGrpSpPr>
        <p:grpSpPr>
          <a:xfrm>
            <a:off x="2085714" y="1045753"/>
            <a:ext cx="2530825" cy="3068222"/>
            <a:chOff x="752884" y="1583025"/>
            <a:chExt cx="2530825" cy="3068222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39B0A2E-1771-9F3F-F51B-A29195A07DE2}"/>
                </a:ext>
              </a:extLst>
            </p:cNvPr>
            <p:cNvSpPr txBox="1"/>
            <p:nvPr/>
          </p:nvSpPr>
          <p:spPr>
            <a:xfrm>
              <a:off x="1443141" y="1583025"/>
              <a:ext cx="184056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0 nM THZ531</a:t>
              </a:r>
            </a:p>
            <a:p>
              <a:r>
                <a:rPr lang="en-NO" sz="1200" dirty="0">
                  <a:latin typeface="Helvetica" pitchFamily="2" charset="0"/>
                </a:rPr>
                <a:t>DMSO – 6h – 24h – 48h</a:t>
              </a:r>
              <a:endParaRPr lang="en-NO" sz="12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75C9ECE-51E0-69AE-0999-97B50D733511}"/>
                </a:ext>
              </a:extLst>
            </p:cNvPr>
            <p:cNvSpPr txBox="1"/>
            <p:nvPr/>
          </p:nvSpPr>
          <p:spPr>
            <a:xfrm>
              <a:off x="752884" y="3103182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0FC3765-3974-6C0A-91BD-5B2196F03C5D}"/>
                </a:ext>
              </a:extLst>
            </p:cNvPr>
            <p:cNvSpPr txBox="1"/>
            <p:nvPr/>
          </p:nvSpPr>
          <p:spPr>
            <a:xfrm>
              <a:off x="752885" y="3577148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10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8B01AAD-48E6-2295-ED2A-3F05CFC72E6D}"/>
                </a:ext>
              </a:extLst>
            </p:cNvPr>
            <p:cNvSpPr txBox="1"/>
            <p:nvPr/>
          </p:nvSpPr>
          <p:spPr>
            <a:xfrm>
              <a:off x="828282" y="3781286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50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8E1A0B1-7397-A589-B786-223983CF30E0}"/>
                </a:ext>
              </a:extLst>
            </p:cNvPr>
            <p:cNvSpPr txBox="1"/>
            <p:nvPr/>
          </p:nvSpPr>
          <p:spPr>
            <a:xfrm>
              <a:off x="828282" y="4374248"/>
              <a:ext cx="115669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NO" sz="1200" dirty="0">
                  <a:latin typeface="Helvetica" pitchFamily="2" charset="0"/>
                </a:rPr>
                <a:t>25 kDa </a:t>
              </a:r>
              <a:r>
                <a:rPr lang="en-NO" sz="1200" b="1" dirty="0">
                  <a:latin typeface="Helvetica" pitchFamily="2" charset="0"/>
                </a:rPr>
                <a:t>–</a:t>
              </a:r>
            </a:p>
          </p:txBody>
        </p:sp>
      </p:grpSp>
      <p:pic>
        <p:nvPicPr>
          <p:cNvPr id="25" name="Bilde 13" descr="Et bilde som inneholder tekst, hvit&#10;&#10;Automatisk generert beskrivelse">
            <a:extLst>
              <a:ext uri="{FF2B5EF4-FFF2-40B4-BE49-F238E27FC236}">
                <a16:creationId xmlns:a16="http://schemas.microsoft.com/office/drawing/2014/main" id="{175BB291-67BB-4E94-9593-65FFC5AB8B4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2902" t="19413" r="19715" b="10635"/>
          <a:stretch>
            <a:fillRect/>
          </a:stretch>
        </p:blipFill>
        <p:spPr bwMode="auto">
          <a:xfrm>
            <a:off x="2879615" y="1711556"/>
            <a:ext cx="1444097" cy="2599386"/>
          </a:xfrm>
          <a:prstGeom prst="rect">
            <a:avLst/>
          </a:prstGeom>
          <a:ln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E2D79AB0-A0C6-38C4-B0CD-BDC97BD9AB65}"/>
              </a:ext>
            </a:extLst>
          </p:cNvPr>
          <p:cNvSpPr/>
          <p:nvPr/>
        </p:nvSpPr>
        <p:spPr>
          <a:xfrm>
            <a:off x="3031369" y="1840759"/>
            <a:ext cx="1244673" cy="430924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2068D3D-9D60-3DD8-ED1B-EA81F9E6F261}"/>
              </a:ext>
            </a:extLst>
          </p:cNvPr>
          <p:cNvSpPr/>
          <p:nvPr/>
        </p:nvSpPr>
        <p:spPr>
          <a:xfrm>
            <a:off x="3206120" y="6231743"/>
            <a:ext cx="1244183" cy="281075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940872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7B9D0D4-6B17-D8CE-2450-371DE509225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3CC5DD81-9D1C-F9C5-EA0B-DEA9855CF3A0}"/>
              </a:ext>
            </a:extLst>
          </p:cNvPr>
          <p:cNvGrpSpPr/>
          <p:nvPr/>
        </p:nvGrpSpPr>
        <p:grpSpPr>
          <a:xfrm>
            <a:off x="960331" y="597411"/>
            <a:ext cx="4261054" cy="3701126"/>
            <a:chOff x="960331" y="563094"/>
            <a:chExt cx="3535959" cy="3071313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124222A2-141F-88CE-083C-8C727FA1326D}"/>
                </a:ext>
              </a:extLst>
            </p:cNvPr>
            <p:cNvSpPr txBox="1"/>
            <p:nvPr/>
          </p:nvSpPr>
          <p:spPr>
            <a:xfrm>
              <a:off x="960331" y="563094"/>
              <a:ext cx="28850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O" sz="1400" b="1" dirty="0">
                  <a:latin typeface="Helvetica" pitchFamily="2" charset="0"/>
                </a:rPr>
                <a:t>Hela:</a:t>
              </a:r>
              <a:r>
                <a:rPr lang="en-NO" sz="1400" dirty="0">
                  <a:latin typeface="Helvetica" pitchFamily="2" charset="0"/>
                </a:rPr>
                <a:t> pSer7</a:t>
              </a: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B5ED77BE-CCB4-E278-4120-69FCEEAD9CD9}"/>
                </a:ext>
              </a:extLst>
            </p:cNvPr>
            <p:cNvGrpSpPr/>
            <p:nvPr/>
          </p:nvGrpSpPr>
          <p:grpSpPr>
            <a:xfrm>
              <a:off x="2065205" y="563094"/>
              <a:ext cx="2431085" cy="2333342"/>
              <a:chOff x="852624" y="1583025"/>
              <a:chExt cx="2431085" cy="2333342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7D75219E-D213-1E52-F01E-F817055ED149}"/>
                  </a:ext>
                </a:extLst>
              </p:cNvPr>
              <p:cNvSpPr txBox="1"/>
              <p:nvPr/>
            </p:nvSpPr>
            <p:spPr>
              <a:xfrm>
                <a:off x="1443141" y="1583025"/>
                <a:ext cx="184056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O" sz="1200" dirty="0">
                    <a:latin typeface="Helvetica" pitchFamily="2" charset="0"/>
                  </a:rPr>
                  <a:t>500 nM THZ531</a:t>
                </a:r>
              </a:p>
              <a:p>
                <a:r>
                  <a:rPr lang="en-NO" sz="1200" dirty="0">
                    <a:latin typeface="Helvetica" pitchFamily="2" charset="0"/>
                  </a:rPr>
                  <a:t>DMSO – 6h – 24h – 48h</a:t>
                </a:r>
                <a:endParaRPr lang="en-NO" sz="1200" dirty="0"/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65177AA7-3B52-936A-59C8-A977E66160F8}"/>
                  </a:ext>
                </a:extLst>
              </p:cNvPr>
              <p:cNvSpPr txBox="1"/>
              <p:nvPr/>
            </p:nvSpPr>
            <p:spPr>
              <a:xfrm>
                <a:off x="852624" y="3056867"/>
                <a:ext cx="115669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NO" sz="1200" dirty="0">
                    <a:latin typeface="Helvetica" pitchFamily="2" charset="0"/>
                  </a:rPr>
                  <a:t>150 kDa </a:t>
                </a:r>
                <a:r>
                  <a:rPr lang="en-NO" sz="1200" b="1" dirty="0">
                    <a:latin typeface="Helvetica" pitchFamily="2" charset="0"/>
                  </a:rPr>
                  <a:t>–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B59E72C2-CD60-EA48-870E-BA70A3A7256C}"/>
                  </a:ext>
                </a:extLst>
              </p:cNvPr>
              <p:cNvSpPr txBox="1"/>
              <p:nvPr/>
            </p:nvSpPr>
            <p:spPr>
              <a:xfrm>
                <a:off x="852624" y="3639368"/>
                <a:ext cx="115669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NO" sz="1200" dirty="0">
                    <a:latin typeface="Helvetica" pitchFamily="2" charset="0"/>
                  </a:rPr>
                  <a:t>100 kDa </a:t>
                </a:r>
                <a:r>
                  <a:rPr lang="en-NO" sz="1200" b="1" dirty="0">
                    <a:latin typeface="Helvetica" pitchFamily="2" charset="0"/>
                  </a:rPr>
                  <a:t>–</a:t>
                </a:r>
              </a:p>
            </p:txBody>
          </p:sp>
        </p:grpSp>
        <p:pic>
          <p:nvPicPr>
            <p:cNvPr id="18" name="Bilde 14" descr="Et bilde som inneholder tekst, enhet&#10;&#10;Automatisk generert beskrivelse">
              <a:extLst>
                <a:ext uri="{FF2B5EF4-FFF2-40B4-BE49-F238E27FC236}">
                  <a16:creationId xmlns:a16="http://schemas.microsoft.com/office/drawing/2014/main" id="{39A6A666-FE85-DC3C-66A8-F13CB452B4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8791" t="23389" r="23051" b="8006"/>
            <a:stretch>
              <a:fillRect/>
            </a:stretch>
          </p:blipFill>
          <p:spPr bwMode="auto">
            <a:xfrm>
              <a:off x="2714302" y="1056289"/>
              <a:ext cx="1501956" cy="2578118"/>
            </a:xfrm>
            <a:prstGeom prst="rect">
              <a:avLst/>
            </a:prstGeom>
            <a:ln>
              <a:solidFill>
                <a:schemeClr val="tx1"/>
              </a:solidFill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14515CD0-7C65-0937-9FB6-D4541C36AE08}"/>
                </a:ext>
              </a:extLst>
            </p:cNvPr>
            <p:cNvSpPr/>
            <p:nvPr/>
          </p:nvSpPr>
          <p:spPr>
            <a:xfrm>
              <a:off x="2860452" y="1169886"/>
              <a:ext cx="1137096" cy="307777"/>
            </a:xfrm>
            <a:prstGeom prst="rect">
              <a:avLst/>
            </a:prstGeom>
            <a:noFill/>
            <a:ln>
              <a:solidFill>
                <a:schemeClr val="bg2">
                  <a:lumMod val="50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O"/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40709C63-48E8-B382-133A-393A98386EB9}"/>
              </a:ext>
            </a:extLst>
          </p:cNvPr>
          <p:cNvGrpSpPr/>
          <p:nvPr/>
        </p:nvGrpSpPr>
        <p:grpSpPr>
          <a:xfrm>
            <a:off x="960331" y="5330922"/>
            <a:ext cx="4357045" cy="3585768"/>
            <a:chOff x="706189" y="5150346"/>
            <a:chExt cx="3535959" cy="2910029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D5AA392-5B1D-665F-A48A-064471BD4B99}"/>
                </a:ext>
              </a:extLst>
            </p:cNvPr>
            <p:cNvSpPr txBox="1"/>
            <p:nvPr/>
          </p:nvSpPr>
          <p:spPr>
            <a:xfrm>
              <a:off x="706189" y="5150346"/>
              <a:ext cx="28850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O" sz="1400" b="1" dirty="0">
                  <a:latin typeface="Helvetica" pitchFamily="2" charset="0"/>
                </a:rPr>
                <a:t>Hela:</a:t>
              </a:r>
              <a:r>
                <a:rPr lang="en-NO" sz="1400" dirty="0">
                  <a:latin typeface="Helvetica" pitchFamily="2" charset="0"/>
                </a:rPr>
                <a:t> Vinculin</a:t>
              </a:r>
            </a:p>
          </p:txBody>
        </p: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2A49D0EF-AAE0-8019-6F99-1E5D86A1026C}"/>
                </a:ext>
              </a:extLst>
            </p:cNvPr>
            <p:cNvGrpSpPr/>
            <p:nvPr/>
          </p:nvGrpSpPr>
          <p:grpSpPr>
            <a:xfrm>
              <a:off x="1843169" y="5150346"/>
              <a:ext cx="2398979" cy="2182846"/>
              <a:chOff x="884730" y="1583025"/>
              <a:chExt cx="2398979" cy="2182846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98336CDD-8FD0-4A51-995B-4B628DF5032E}"/>
                  </a:ext>
                </a:extLst>
              </p:cNvPr>
              <p:cNvSpPr txBox="1"/>
              <p:nvPr/>
            </p:nvSpPr>
            <p:spPr>
              <a:xfrm>
                <a:off x="1443141" y="1583025"/>
                <a:ext cx="184056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O" sz="1200" dirty="0">
                    <a:latin typeface="Helvetica" pitchFamily="2" charset="0"/>
                  </a:rPr>
                  <a:t>500 nM THZ531</a:t>
                </a:r>
              </a:p>
              <a:p>
                <a:r>
                  <a:rPr lang="en-NO" sz="1200" dirty="0">
                    <a:latin typeface="Helvetica" pitchFamily="2" charset="0"/>
                  </a:rPr>
                  <a:t>DMSO – 6h – 24h – 48h</a:t>
                </a:r>
                <a:endParaRPr lang="en-NO" sz="1200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D583B3F7-F392-2DCA-02F4-747A02E843C6}"/>
                  </a:ext>
                </a:extLst>
              </p:cNvPr>
              <p:cNvSpPr txBox="1"/>
              <p:nvPr/>
            </p:nvSpPr>
            <p:spPr>
              <a:xfrm>
                <a:off x="884730" y="2937336"/>
                <a:ext cx="115669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NO" sz="1200" dirty="0">
                    <a:latin typeface="Helvetica" pitchFamily="2" charset="0"/>
                  </a:rPr>
                  <a:t>150 kDa </a:t>
                </a:r>
                <a:r>
                  <a:rPr lang="en-NO" sz="1200" b="1" dirty="0">
                    <a:latin typeface="Helvetica" pitchFamily="2" charset="0"/>
                  </a:rPr>
                  <a:t>–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7535AA13-2E41-3B17-B668-B3A65024C201}"/>
                  </a:ext>
                </a:extLst>
              </p:cNvPr>
              <p:cNvSpPr txBox="1"/>
              <p:nvPr/>
            </p:nvSpPr>
            <p:spPr>
              <a:xfrm>
                <a:off x="884730" y="3488872"/>
                <a:ext cx="115669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NO" sz="1200" dirty="0">
                    <a:latin typeface="Helvetica" pitchFamily="2" charset="0"/>
                  </a:rPr>
                  <a:t>100 kDa </a:t>
                </a:r>
                <a:r>
                  <a:rPr lang="en-NO" sz="1200" b="1" dirty="0">
                    <a:latin typeface="Helvetica" pitchFamily="2" charset="0"/>
                  </a:rPr>
                  <a:t>–</a:t>
                </a:r>
              </a:p>
            </p:txBody>
          </p:sp>
        </p:grpSp>
        <p:pic>
          <p:nvPicPr>
            <p:cNvPr id="19" name="Bilde 12" descr="Et bilde som inneholder tekst&#10;&#10;Automatisk generert beskrivelse">
              <a:extLst>
                <a:ext uri="{FF2B5EF4-FFF2-40B4-BE49-F238E27FC236}">
                  <a16:creationId xmlns:a16="http://schemas.microsoft.com/office/drawing/2014/main" id="{2652C2D0-76BB-04F1-955A-F40268143D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4734" t="27906" r="44860" b="5517"/>
            <a:stretch>
              <a:fillRect/>
            </a:stretch>
          </p:blipFill>
          <p:spPr bwMode="auto">
            <a:xfrm>
              <a:off x="2490058" y="5631996"/>
              <a:ext cx="1573967" cy="2428379"/>
            </a:xfrm>
            <a:prstGeom prst="rect">
              <a:avLst/>
            </a:prstGeom>
            <a:ln>
              <a:solidFill>
                <a:schemeClr val="tx1"/>
              </a:solidFill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841B4D8B-FA6A-0285-34C5-B4649C57F694}"/>
                </a:ext>
              </a:extLst>
            </p:cNvPr>
            <p:cNvSpPr/>
            <p:nvPr/>
          </p:nvSpPr>
          <p:spPr>
            <a:xfrm>
              <a:off x="2709637" y="6801641"/>
              <a:ext cx="1180747" cy="393052"/>
            </a:xfrm>
            <a:prstGeom prst="rect">
              <a:avLst/>
            </a:prstGeom>
            <a:noFill/>
            <a:ln>
              <a:solidFill>
                <a:schemeClr val="bg2">
                  <a:lumMod val="50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O"/>
            </a:p>
          </p:txBody>
        </p:sp>
      </p:grpSp>
    </p:spTree>
    <p:extLst>
      <p:ext uri="{BB962C8B-B14F-4D97-AF65-F5344CB8AC3E}">
        <p14:creationId xmlns:p14="http://schemas.microsoft.com/office/powerpoint/2010/main" val="3204870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</TotalTime>
  <Words>265</Words>
  <Application>Microsoft Macintosh PowerPoint</Application>
  <PresentationFormat>A4 Paper (210x297 mm)</PresentationFormat>
  <Paragraphs>7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Bachmann Markusson</dc:creator>
  <cp:lastModifiedBy>Sara Bachmann Markusson</cp:lastModifiedBy>
  <cp:revision>1</cp:revision>
  <dcterms:created xsi:type="dcterms:W3CDTF">2025-12-11T13:03:02Z</dcterms:created>
  <dcterms:modified xsi:type="dcterms:W3CDTF">2025-12-11T14:12:17Z</dcterms:modified>
</cp:coreProperties>
</file>